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F56649-4390-4B24-ACC1-0EB7D14C2BA0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7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36EE7A-9D51-4F82-A8AB-C4DCC4AB5C0E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ECFBD-B386-49A5-93D7-F06E7FE10B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EA283-AF48-4D13-B947-A3CBBF12DB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FDD7C-E811-445B-BC02-608546D725A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7FFFF3-4DA7-4D04-9DA3-CA370B239A7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620BD4-41A2-4BDA-98A4-105AA51BAE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7AC2E2-7AD3-494E-ABB3-5669376F2D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5DD48-97AB-4691-A713-3F29EF59505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6C199-2AE4-4C29-955A-3372B70BB0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A00807-84AC-4AF5-B242-0A13A9ED9D3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A8427-E0ED-4E2E-A92F-A0EEEE1FA3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28195F-5A9B-44DB-8DA1-CA5CBE7AB4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C06233-137A-4FD7-8EAE-450F1D3E0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87E3A2-57C5-4CC4-84FE-CA05FA61EEF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21"/>
          <p:cNvGrpSpPr/>
          <p:nvPr/>
        </p:nvGrpSpPr>
        <p:grpSpPr>
          <a:xfrm>
            <a:off x="1655640" y="3363840"/>
            <a:ext cx="4800600" cy="2746800"/>
            <a:chOff x="1655640" y="3363840"/>
            <a:chExt cx="4800600" cy="2746800"/>
          </a:xfrm>
        </p:grpSpPr>
        <p:pic>
          <p:nvPicPr>
            <p:cNvPr id="49" name="Picture 1" descr="C:\Users\awanliyun\Documents\Tencent Files\179260223\Image\C2C\~9MB6IRUO)LWA6A@T14A377.png"/>
            <p:cNvPicPr/>
            <p:nvPr/>
          </p:nvPicPr>
          <p:blipFill>
            <a:blip r:embed="rId1"/>
            <a:srcRect l="7253" t="0" r="12597" b="6111"/>
            <a:stretch/>
          </p:blipFill>
          <p:spPr>
            <a:xfrm>
              <a:off x="1989000" y="3403080"/>
              <a:ext cx="3600720" cy="2476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Box 4"/>
            <p:cNvSpPr/>
            <p:nvPr/>
          </p:nvSpPr>
          <p:spPr>
            <a:xfrm>
              <a:off x="1663200" y="336384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5"/>
            <p:cNvSpPr/>
            <p:nvPr/>
          </p:nvSpPr>
          <p:spPr>
            <a:xfrm>
              <a:off x="1659240" y="413856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6"/>
            <p:cNvSpPr/>
            <p:nvPr/>
          </p:nvSpPr>
          <p:spPr>
            <a:xfrm>
              <a:off x="1655640" y="491724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7"/>
            <p:cNvSpPr/>
            <p:nvPr/>
          </p:nvSpPr>
          <p:spPr>
            <a:xfrm>
              <a:off x="1808640" y="56851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8"/>
            <p:cNvSpPr/>
            <p:nvPr/>
          </p:nvSpPr>
          <p:spPr>
            <a:xfrm>
              <a:off x="191772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16: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9"/>
            <p:cNvSpPr/>
            <p:nvPr/>
          </p:nvSpPr>
          <p:spPr>
            <a:xfrm>
              <a:off x="232308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18: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0"/>
            <p:cNvSpPr/>
            <p:nvPr/>
          </p:nvSpPr>
          <p:spPr>
            <a:xfrm>
              <a:off x="274392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18: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11"/>
            <p:cNvSpPr/>
            <p:nvPr/>
          </p:nvSpPr>
          <p:spPr>
            <a:xfrm>
              <a:off x="313488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18: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2"/>
            <p:cNvSpPr/>
            <p:nvPr/>
          </p:nvSpPr>
          <p:spPr>
            <a:xfrm>
              <a:off x="469836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24: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13"/>
            <p:cNvSpPr/>
            <p:nvPr/>
          </p:nvSpPr>
          <p:spPr>
            <a:xfrm>
              <a:off x="352908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20: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Box 14"/>
            <p:cNvSpPr/>
            <p:nvPr/>
          </p:nvSpPr>
          <p:spPr>
            <a:xfrm>
              <a:off x="393696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20: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15"/>
            <p:cNvSpPr/>
            <p:nvPr/>
          </p:nvSpPr>
          <p:spPr>
            <a:xfrm>
              <a:off x="4320000" y="586332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22: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Box 16"/>
            <p:cNvSpPr/>
            <p:nvPr/>
          </p:nvSpPr>
          <p:spPr>
            <a:xfrm>
              <a:off x="5099040" y="5864400"/>
              <a:ext cx="68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ther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3" name="Picture 2" descr="J:\白皮突变体文章201802\FA barplot.png"/>
            <p:cNvPicPr/>
            <p:nvPr/>
          </p:nvPicPr>
          <p:blipFill>
            <a:blip r:embed="rId2"/>
            <a:srcRect l="88938" t="44345" r="6486" b="46608"/>
            <a:stretch/>
          </p:blipFill>
          <p:spPr>
            <a:xfrm>
              <a:off x="5633280" y="4149360"/>
              <a:ext cx="285480" cy="331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4" name="TextBox 17"/>
            <p:cNvSpPr/>
            <p:nvPr/>
          </p:nvSpPr>
          <p:spPr>
            <a:xfrm>
              <a:off x="5871240" y="409104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18"/>
            <p:cNvSpPr/>
            <p:nvPr/>
          </p:nvSpPr>
          <p:spPr>
            <a:xfrm>
              <a:off x="5884920" y="4251960"/>
              <a:ext cx="57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TextBox 19"/>
          <p:cNvSpPr/>
          <p:nvPr/>
        </p:nvSpPr>
        <p:spPr>
          <a:xfrm>
            <a:off x="806400" y="18252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7" name=""/>
          <p:cNvGraphicFramePr/>
          <p:nvPr/>
        </p:nvGraphicFramePr>
        <p:xfrm>
          <a:off x="1357200" y="357120"/>
          <a:ext cx="4572000" cy="2871720"/>
        </p:xfrm>
        <a:graphic>
          <a:graphicData uri="http://schemas.openxmlformats.org/drawingml/2006/table">
            <a:tbl>
              <a:tblPr/>
              <a:tblGrid>
                <a:gridCol w="2786040"/>
                <a:gridCol w="285840"/>
                <a:gridCol w="403200"/>
                <a:gridCol w="484200"/>
                <a:gridCol w="612720"/>
              </a:tblGrid>
              <a:tr h="31176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thway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unt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ow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athway I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020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etabolic pathway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11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iosynthesis of secondary metabolit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11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20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soflavonoid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9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avonoid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9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lavone and flavonol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9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20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rphyrin and chlorophyll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8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48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enylpropanoid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9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ilbenoid, diarylheptanoid and gingerol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9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48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onobactam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2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nthocyanin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9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20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-Oxocarboxylic acid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12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utin, suberine and wax biosynthe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0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6020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yrosine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3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84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henylalanine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3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48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lycerophospholipid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056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59480"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atty acid metabolis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" rIns="6840" tIns="68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p012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" marR="68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8" name="TextBox 22"/>
          <p:cNvSpPr/>
          <p:nvPr/>
        </p:nvSpPr>
        <p:spPr>
          <a:xfrm>
            <a:off x="806400" y="339264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矩形 1"/>
          <p:cNvSpPr/>
          <p:nvPr/>
        </p:nvSpPr>
        <p:spPr>
          <a:xfrm>
            <a:off x="476280" y="6372360"/>
            <a:ext cx="61657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1. Cotyledon metabolism and fatty acid contents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(A) Enriched KEGG pathways of cotyledon metabolism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(B) Fatty acid contents i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33:27Z</dcterms:modified>
  <cp:revision>8</cp:revision>
  <dc:subject/>
  <dc:title>幻灯片 1</dc:title>
</cp:coreProperties>
</file>